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106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14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1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106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8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87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90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309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62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0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60AD8-C547-4650-916F-C4A20F15F848}" type="datetimeFigureOut">
              <a:rPr lang="en-US" smtClean="0"/>
              <a:t>4/21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4C68E-32A3-42FE-BFD0-18025A6B5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9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930785" y="464904"/>
            <a:ext cx="95681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Fig: Combination of PI3K inhibitor LY294002 with rapamycin enhances the residual DNA-DSBs only in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on-responder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4"/>
          <a:stretch/>
        </p:blipFill>
        <p:spPr>
          <a:xfrm>
            <a:off x="3415146" y="1172876"/>
            <a:ext cx="5760720" cy="5013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6156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htoul04a</dc:creator>
  <cp:lastModifiedBy>MT</cp:lastModifiedBy>
  <cp:revision>19</cp:revision>
  <dcterms:created xsi:type="dcterms:W3CDTF">2015-08-27T14:11:55Z</dcterms:created>
  <dcterms:modified xsi:type="dcterms:W3CDTF">2016-04-21T10:39:40Z</dcterms:modified>
</cp:coreProperties>
</file>